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9" r:id="rId3"/>
    <p:sldId id="258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93" d="100"/>
          <a:sy n="93" d="100"/>
        </p:scale>
        <p:origin x="46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812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292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111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018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94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283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425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627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532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801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732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B17BF-F7FB-48C8-9410-5A075D15CBB0}" type="datetimeFigureOut">
              <a:rPr lang="en-US" smtClean="0"/>
              <a:t>5/3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0DCB52-6909-47B5-9587-D25BE929FA4A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028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000" y="193109"/>
            <a:ext cx="3060000" cy="617221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439507" y="6516401"/>
            <a:ext cx="2995383" cy="30469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Phylogenetic trees based on the Neighbor joining algorithm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ORF1 amino acid sequenc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TLV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in green) compared to other viruses of the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al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rder with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ph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arker red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t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red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taflexivirida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purple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mm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ight red) and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ifferent shade of blue),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ula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arker blue)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afi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blue) and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ight blue). Unassig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rus with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order are shown in yellow and 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dicat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lassified virus within 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u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otstrap values over 0.50 are show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18786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243639" y="183921"/>
            <a:ext cx="6480000" cy="6498327"/>
            <a:chOff x="243639" y="183921"/>
            <a:chExt cx="6480000" cy="6498327"/>
          </a:xfrm>
        </p:grpSpPr>
        <p:grpSp>
          <p:nvGrpSpPr>
            <p:cNvPr id="2" name="Groupe 1"/>
            <p:cNvGrpSpPr/>
            <p:nvPr/>
          </p:nvGrpSpPr>
          <p:grpSpPr>
            <a:xfrm>
              <a:off x="243639" y="183921"/>
              <a:ext cx="6480000" cy="6498327"/>
              <a:chOff x="243639" y="183921"/>
              <a:chExt cx="7589983" cy="6498327"/>
            </a:xfrm>
          </p:grpSpPr>
          <p:pic>
            <p:nvPicPr>
              <p:cNvPr id="3" name="Image 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1760" y="183921"/>
                <a:ext cx="3721862" cy="6498327"/>
              </a:xfrm>
              <a:prstGeom prst="rect">
                <a:avLst/>
              </a:prstGeom>
            </p:spPr>
          </p:pic>
          <p:pic>
            <p:nvPicPr>
              <p:cNvPr id="4" name="Image 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3639" y="183921"/>
                <a:ext cx="3632283" cy="6316579"/>
              </a:xfrm>
              <a:prstGeom prst="rect">
                <a:avLst/>
              </a:prstGeom>
            </p:spPr>
          </p:pic>
        </p:grpSp>
        <p:sp>
          <p:nvSpPr>
            <p:cNvPr id="5" name="ZoneTexte 4"/>
            <p:cNvSpPr txBox="1"/>
            <p:nvPr/>
          </p:nvSpPr>
          <p:spPr>
            <a:xfrm>
              <a:off x="243639" y="238626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A</a:t>
              </a:r>
              <a:endParaRPr lang="en-US" dirty="0"/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546074" y="238626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B</a:t>
              </a:r>
              <a:endParaRPr lang="en-US" dirty="0"/>
            </a:p>
          </p:txBody>
        </p:sp>
      </p:grpSp>
      <p:sp>
        <p:nvSpPr>
          <p:cNvPr id="7" name="Rectangle 6"/>
          <p:cNvSpPr/>
          <p:nvPr/>
        </p:nvSpPr>
        <p:spPr>
          <a:xfrm>
            <a:off x="310914" y="6864174"/>
            <a:ext cx="647032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Phylogenetic trees based on the Maximum likelihood algorithm of (A) Hel and (B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dR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omains 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TLV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in green) compared to other viruses of the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al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rder with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ph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arker red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et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red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taflexivirida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purple),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mmaflexi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ight red) and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ida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ifferent shade of blue), with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ula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darker blue),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afi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blue) and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ymoviruses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light blue). Unassign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irus within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order are shown in yellow and 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dicat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nclassified virus within a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enus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ootstrap values over 0.50 are show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38403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1567368" y="2688172"/>
            <a:ext cx="9648081" cy="4955899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895483" y="10124585"/>
            <a:ext cx="527330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: Protein structure analyses performed by I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sse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bsite (https://zhanglab.ccmb.med.umich.edu/I-TASSER/),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ith the three best structural analogs found in PDB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679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234</Words>
  <Application>Microsoft Office PowerPoint</Application>
  <PresentationFormat>Grand écran</PresentationFormat>
  <Paragraphs>5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Michel Hily</dc:creator>
  <cp:lastModifiedBy>Jean-Michel Hily</cp:lastModifiedBy>
  <cp:revision>2</cp:revision>
  <dcterms:created xsi:type="dcterms:W3CDTF">2018-05-30T14:52:27Z</dcterms:created>
  <dcterms:modified xsi:type="dcterms:W3CDTF">2018-05-30T15:05:37Z</dcterms:modified>
</cp:coreProperties>
</file>